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D85EC0-35E6-4702-8990-A19F6ABFE7E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9DB529-AF49-4886-8A87-9BFFDBD5AD1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8CA4BA-34C8-40FC-865E-E7C01FFBCB6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0AFFD3-71C1-4FC4-A4E3-43EB821B402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FCD3C0-F44F-4524-B29B-F4D30E8671C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B5562F-F86C-47D0-90D3-21398DBE243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00875D-F957-4C3A-9B0A-C032E175682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2EA4F2-1D41-4990-98C4-2D1A8897989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A3A6E7-65EE-42CA-B9B0-C23557C9120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8E96D3-33B0-4B65-9440-E0D03BA1F49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C28E5F-6B16-4579-A20D-1D45675C475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8AFBD3-B244-404F-BA78-7290C401DD6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F8FC8B73-41A7-4355-AC34-7842DE1F2CC4}" type="datetime">
              <a:rPr b="0" lang="en-US" sz="12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249F7DEA-F297-487D-979F-BE72C2CD30AA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1143000" y="1219320"/>
          <a:ext cx="6858000" cy="4343400"/>
        </p:xfrm>
        <a:graphic>
          <a:graphicData uri="http://schemas.openxmlformats.org/drawingml/2006/table">
            <a:tbl>
              <a:tblPr/>
              <a:tblGrid>
                <a:gridCol w="982800"/>
                <a:gridCol w="920520"/>
                <a:gridCol w="1076400"/>
                <a:gridCol w="941400"/>
                <a:gridCol w="939960"/>
                <a:gridCol w="1025280"/>
                <a:gridCol w="971640"/>
              </a:tblGrid>
              <a:tr h="1396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3"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Densitometry reading (normalized*)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112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Timepoints (min)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Supernatant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Pellet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Sum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Weight (t)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Weighted valu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968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1927646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82331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2009978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X 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100498905.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968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1756883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255667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2012550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X 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100627542.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968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1640634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280741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1921375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X 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96068771.0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148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1524700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575622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2100323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X 1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210032329.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968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1677858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382856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2060715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X 2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412143036.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968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1695698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188442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1884141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X 1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282621197.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968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1742067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151377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1893445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X 1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284016801.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112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1704810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201589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1906399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X 1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285959972.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96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96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Weighted sum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177196855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112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AVG (/90)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1968854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96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96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9680">
                <a:tc gridSpan="3" rowSpan="3"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* Values are normalized to intensity of Ponceau S staining as well as concentration ratios of supernatant to pellet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 row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 row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Mol/cell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1730 [45]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1480">
                <a:tc vMerge="1" grid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Scaling factor =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(mol/cell)/AVG =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8.79E-0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9680">
                <a:tc vMerge="1" grid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96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9680">
                <a:tc gridSpan="3" rowSpan="4"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 row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 row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3" rowSpan="2"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Multiply each timepoint by scaling factor to generate scaled data: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hMerge="1" row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 row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41120">
                <a:tc vMerge="1" grid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 grid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39680">
                <a:tc vMerge="1" grid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Supernatant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Pellet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39680">
                <a:tc vMerge="1" grid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169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7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00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154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22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12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144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24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396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134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50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396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147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33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396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149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16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4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153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13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396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149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17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2" name="TextBox 4"/>
          <p:cNvSpPr/>
          <p:nvPr/>
        </p:nvSpPr>
        <p:spPr>
          <a:xfrm>
            <a:off x="1066680" y="642960"/>
            <a:ext cx="693432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Table S1. Sample conversion of densitometry values to cellular abundance for one Cdc45-Myc timecourse experiment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4-18T19:16:35Z</dcterms:created>
  <dc:creator>Rohan Gidvani</dc:creator>
  <dc:description/>
  <dc:language>en-US</dc:language>
  <cp:lastModifiedBy>Rohan Gidvani</cp:lastModifiedBy>
  <dcterms:modified xsi:type="dcterms:W3CDTF">2012-06-17T22:23:51Z</dcterms:modified>
  <cp:revision>3</cp:revision>
  <dc:subject/>
  <dc:title>Slide 1</dc:title>
</cp:coreProperties>
</file>